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63" r:id="rId2"/>
  </p:sldIdLst>
  <p:sldSz cx="6254750" cy="8458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. Figure 4" id="{17B9AB10-C582-45EA-8F52-FC78628F7EE2}">
          <p14:sldIdLst>
            <p14:sldId id="263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9" clrIdx="0">
    <p:extLst>
      <p:ext uri="{19B8F6BF-5375-455C-9EA6-DF929625EA0E}">
        <p15:presenceInfo xmlns:p15="http://schemas.microsoft.com/office/powerpoint/2012/main" userId="USER" providerId="None"/>
      </p:ext>
    </p:extLst>
  </p:cmAuthor>
  <p:cmAuthor id="2" name="skarimi" initials="s" lastIdx="4" clrIdx="1">
    <p:extLst>
      <p:ext uri="{19B8F6BF-5375-455C-9EA6-DF929625EA0E}">
        <p15:presenceInfo xmlns:p15="http://schemas.microsoft.com/office/powerpoint/2012/main" userId="skarimi" providerId="None"/>
      </p:ext>
    </p:extLst>
  </p:cmAuthor>
  <p:cmAuthor id="3" name="soheila karimi" initials="sk" lastIdx="6" clrIdx="2">
    <p:extLst>
      <p:ext uri="{19B8F6BF-5375-455C-9EA6-DF929625EA0E}">
        <p15:presenceInfo xmlns:p15="http://schemas.microsoft.com/office/powerpoint/2012/main" userId="bb0168d6462bdfd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D222"/>
    <a:srgbClr val="EAB200"/>
    <a:srgbClr val="EA6B14"/>
    <a:srgbClr val="3333FF"/>
    <a:srgbClr val="00FF00"/>
    <a:srgbClr val="1DFF1D"/>
    <a:srgbClr val="000300"/>
    <a:srgbClr val="66A2D8"/>
    <a:srgbClr val="84B4E0"/>
    <a:srgbClr val="5F5FD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26" autoAdjust="0"/>
    <p:restoredTop sz="86861" autoAdjust="0"/>
  </p:normalViewPr>
  <p:slideViewPr>
    <p:cSldViewPr snapToGrid="0">
      <p:cViewPr varScale="1">
        <p:scale>
          <a:sx n="60" d="100"/>
          <a:sy n="60" d="100"/>
        </p:scale>
        <p:origin x="22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karinas.scrc.umanitoba.ca\Ghazaleh\ICC%20Imaging\NPCs%20experiment\Differentiation%20assay\Thesis-Differentiation%20assay-NPCs\Differentiation%20assay-NG2-22-08-2018\Analysis-NG2-26-06-201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karinas.scrc.umanitoba.ca\Ghazaleh\ICC%20Imaging\NPCs%20experiment\Differentiation%20assay\Thesis-Differentiation%20assay-NPCs\Differentiation-Olig2-GFAP-6-11-2017\Analysis-Differentiation-Brain%20NPCs-6-11-20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 w="3175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C00000"/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0232-4EE1-9466-74AE1E897867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0232-4EE1-9466-74AE1E89786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0232-4EE1-9466-74AE1E89786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0232-4EE1-9466-74AE1E897867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0232-4EE1-9466-74AE1E897867}"/>
              </c:ext>
            </c:extLst>
          </c:dPt>
          <c:errBars>
            <c:errBarType val="plus"/>
            <c:errValType val="cust"/>
            <c:noEndCap val="0"/>
            <c:plus>
              <c:numRef>
                <c:f>'[Analysis-NG2-26-06-2018.xlsx]Sheet1'!$AM$25:$AM$29</c:f>
                <c:numCache>
                  <c:formatCode>General</c:formatCode>
                  <c:ptCount val="5"/>
                  <c:pt idx="0">
                    <c:v>3.8334695786843858</c:v>
                  </c:pt>
                  <c:pt idx="1">
                    <c:v>2.0556820918574199</c:v>
                  </c:pt>
                  <c:pt idx="2">
                    <c:v>1.6513817436261604</c:v>
                  </c:pt>
                  <c:pt idx="3">
                    <c:v>2.3237392658229057</c:v>
                  </c:pt>
                  <c:pt idx="4">
                    <c:v>1.5002199776858225</c:v>
                  </c:pt>
                </c:numCache>
              </c:numRef>
            </c:plus>
            <c:minus>
              <c:numRef>
                <c:f>'[Analysis-NG2-26-06-2018.xlsx]Sheet1'!$AM$25:$AM$29</c:f>
                <c:numCache>
                  <c:formatCode>General</c:formatCode>
                  <c:ptCount val="5"/>
                  <c:pt idx="0">
                    <c:v>3.8334695786843858</c:v>
                  </c:pt>
                  <c:pt idx="1">
                    <c:v>2.0556820918574199</c:v>
                  </c:pt>
                  <c:pt idx="2">
                    <c:v>1.6513817436261604</c:v>
                  </c:pt>
                  <c:pt idx="3">
                    <c:v>2.3237392658229057</c:v>
                  </c:pt>
                  <c:pt idx="4">
                    <c:v>1.5002199776858225</c:v>
                  </c:pt>
                </c:numCache>
              </c:numRef>
            </c:minus>
          </c:errBars>
          <c:cat>
            <c:strRef>
              <c:f>'[Analysis-NG2-26-06-2018.xlsx]Sheet1'!$AG$25:$AG$29</c:f>
              <c:strCache>
                <c:ptCount val="5"/>
                <c:pt idx="0">
                  <c:v>Control media</c:v>
                </c:pt>
                <c:pt idx="1">
                  <c:v>Incubated Nrg-1 50</c:v>
                </c:pt>
                <c:pt idx="2">
                  <c:v>Fresh Nrg-1 50</c:v>
                </c:pt>
                <c:pt idx="3">
                  <c:v>Incubated Nrg-1 200</c:v>
                </c:pt>
                <c:pt idx="4">
                  <c:v>Fresh Nrg-1 200</c:v>
                </c:pt>
              </c:strCache>
            </c:strRef>
          </c:cat>
          <c:val>
            <c:numRef>
              <c:f>'[Analysis-NG2-26-06-2018.xlsx]Sheet1'!$AL$25:$AL$29</c:f>
              <c:numCache>
                <c:formatCode>General</c:formatCode>
                <c:ptCount val="5"/>
                <c:pt idx="0">
                  <c:v>23.837602173520601</c:v>
                </c:pt>
                <c:pt idx="1">
                  <c:v>27.874196366304162</c:v>
                </c:pt>
                <c:pt idx="2">
                  <c:v>43.545568187178638</c:v>
                </c:pt>
                <c:pt idx="3">
                  <c:v>32.349934316467497</c:v>
                </c:pt>
                <c:pt idx="4">
                  <c:v>46.3167584235648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232-4EE1-9466-74AE1E8978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17679984"/>
        <c:axId val="517680376"/>
      </c:barChart>
      <c:catAx>
        <c:axId val="5176799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300">
                <a:noFill/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517680376"/>
        <c:crosses val="autoZero"/>
        <c:auto val="1"/>
        <c:lblAlgn val="ctr"/>
        <c:lblOffset val="100"/>
        <c:noMultiLvlLbl val="0"/>
      </c:catAx>
      <c:valAx>
        <c:axId val="517680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 b="1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517679984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 w="317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C00000"/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96E-454F-A7B3-0D4FB7C0F827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796E-454F-A7B3-0D4FB7C0F82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796E-454F-A7B3-0D4FB7C0F82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796E-454F-A7B3-0D4FB7C0F827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796E-454F-A7B3-0D4FB7C0F827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6-796E-454F-A7B3-0D4FB7C0F827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796E-454F-A7B3-0D4FB7C0F827}"/>
              </c:ext>
            </c:extLst>
          </c:dPt>
          <c:errBars>
            <c:errBarType val="plus"/>
            <c:errValType val="cust"/>
            <c:noEndCap val="0"/>
            <c:plus>
              <c:numRef>
                <c:f>'N=4-N50 and N200'!$Q$9:$Q$15</c:f>
                <c:numCache>
                  <c:formatCode>General</c:formatCode>
                  <c:ptCount val="7"/>
                  <c:pt idx="0">
                    <c:v>0.85671740098182514</c:v>
                  </c:pt>
                  <c:pt idx="1">
                    <c:v>1.3674886467677361</c:v>
                  </c:pt>
                  <c:pt idx="2">
                    <c:v>2.3370011049139632</c:v>
                  </c:pt>
                  <c:pt idx="3">
                    <c:v>3.9308702932555737</c:v>
                  </c:pt>
                  <c:pt idx="4">
                    <c:v>1.2515535683855028</c:v>
                  </c:pt>
                  <c:pt idx="5">
                    <c:v>2.4310857085314561</c:v>
                  </c:pt>
                  <c:pt idx="6">
                    <c:v>0.72471303318095703</c:v>
                  </c:pt>
                </c:numCache>
              </c:numRef>
            </c:plus>
            <c:minus>
              <c:numRef>
                <c:f>'N=4-N50 and N200'!$Q$9:$Q$15</c:f>
                <c:numCache>
                  <c:formatCode>General</c:formatCode>
                  <c:ptCount val="7"/>
                  <c:pt idx="0">
                    <c:v>0.85671740098182514</c:v>
                  </c:pt>
                  <c:pt idx="1">
                    <c:v>1.3674886467677361</c:v>
                  </c:pt>
                  <c:pt idx="2">
                    <c:v>2.3370011049139632</c:v>
                  </c:pt>
                  <c:pt idx="3">
                    <c:v>3.9308702932555737</c:v>
                  </c:pt>
                  <c:pt idx="4">
                    <c:v>1.2515535683855028</c:v>
                  </c:pt>
                  <c:pt idx="5">
                    <c:v>2.4310857085314561</c:v>
                  </c:pt>
                  <c:pt idx="6">
                    <c:v>0.72471303318095703</c:v>
                  </c:pt>
                </c:numCache>
              </c:numRef>
            </c:minus>
          </c:errBars>
          <c:cat>
            <c:strRef>
              <c:f>'N=4-N50 and N200'!$K$9:$K$15</c:f>
              <c:strCache>
                <c:ptCount val="7"/>
                <c:pt idx="0">
                  <c:v>Control media</c:v>
                </c:pt>
                <c:pt idx="1">
                  <c:v>Incubated N50</c:v>
                </c:pt>
                <c:pt idx="2">
                  <c:v>Fresh N50</c:v>
                </c:pt>
                <c:pt idx="3">
                  <c:v>Incubated N200</c:v>
                </c:pt>
                <c:pt idx="4">
                  <c:v>Fresh N200</c:v>
                </c:pt>
                <c:pt idx="5">
                  <c:v>Incubated IT</c:v>
                </c:pt>
                <c:pt idx="6">
                  <c:v>Fresh IT</c:v>
                </c:pt>
              </c:strCache>
            </c:strRef>
          </c:cat>
          <c:val>
            <c:numRef>
              <c:f>'N=4-N50 and N200'!$P$9:$P$15</c:f>
              <c:numCache>
                <c:formatCode>General</c:formatCode>
                <c:ptCount val="7"/>
                <c:pt idx="0">
                  <c:v>29.395714743185088</c:v>
                </c:pt>
                <c:pt idx="1">
                  <c:v>34.766726826354891</c:v>
                </c:pt>
                <c:pt idx="2">
                  <c:v>48.799731496486828</c:v>
                </c:pt>
                <c:pt idx="3">
                  <c:v>33.559815697893924</c:v>
                </c:pt>
                <c:pt idx="4">
                  <c:v>47.808005480732831</c:v>
                </c:pt>
                <c:pt idx="5">
                  <c:v>30.332819186036851</c:v>
                </c:pt>
                <c:pt idx="6">
                  <c:v>9.57614756648327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96E-454F-A7B3-0D4FB7C0F8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61974400"/>
        <c:axId val="61975936"/>
      </c:barChart>
      <c:catAx>
        <c:axId val="619744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300">
                <a:noFill/>
              </a:defRPr>
            </a:pPr>
            <a:endParaRPr lang="en-US"/>
          </a:p>
        </c:txPr>
        <c:crossAx val="61975936"/>
        <c:crosses val="autoZero"/>
        <c:auto val="1"/>
        <c:lblAlgn val="ctr"/>
        <c:lblOffset val="100"/>
        <c:noMultiLvlLbl val="0"/>
      </c:catAx>
      <c:valAx>
        <c:axId val="619759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50" b="1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619744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281239992314098"/>
          <c:y val="0.11158578807260865"/>
          <c:w val="0.87860804899387579"/>
          <c:h val="0.72155876348789727"/>
        </c:manualLayout>
      </c:layout>
      <c:barChart>
        <c:barDir val="col"/>
        <c:grouping val="clustered"/>
        <c:varyColors val="0"/>
        <c:ser>
          <c:idx val="0"/>
          <c:order val="0"/>
          <c:spPr>
            <a:ln w="3175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C00000"/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3A69-4C54-A1B1-B805BD9818CB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3A69-4C54-A1B1-B805BD9818CB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3A69-4C54-A1B1-B805BD9818CB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3A69-4C54-A1B1-B805BD9818CB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3A69-4C54-A1B1-B805BD9818CB}"/>
              </c:ext>
            </c:extLst>
          </c:dPt>
          <c:errBars>
            <c:errBarType val="plus"/>
            <c:errValType val="cust"/>
            <c:noEndCap val="0"/>
            <c:plus>
              <c:numRef>
                <c:f>'[Analysis-Differentiation-Brain NPCs-6-11-2017.xlsx]N=4'!$T$19:$T$23</c:f>
                <c:numCache>
                  <c:formatCode>General</c:formatCode>
                  <c:ptCount val="5"/>
                  <c:pt idx="0">
                    <c:v>3.1451916843937666</c:v>
                  </c:pt>
                  <c:pt idx="1">
                    <c:v>2.6171873629866189</c:v>
                  </c:pt>
                  <c:pt idx="2">
                    <c:v>2.4588941079218603</c:v>
                  </c:pt>
                  <c:pt idx="3">
                    <c:v>3.269797653162767</c:v>
                  </c:pt>
                  <c:pt idx="4">
                    <c:v>3.1231854450834753</c:v>
                  </c:pt>
                </c:numCache>
              </c:numRef>
            </c:plus>
            <c:minus>
              <c:numRef>
                <c:f>'[Analysis-Differentiation-Brain NPCs-6-11-2017.xlsx]N=4'!$T$19:$T$23</c:f>
                <c:numCache>
                  <c:formatCode>General</c:formatCode>
                  <c:ptCount val="5"/>
                  <c:pt idx="0">
                    <c:v>3.1451916843937666</c:v>
                  </c:pt>
                  <c:pt idx="1">
                    <c:v>2.6171873629866189</c:v>
                  </c:pt>
                  <c:pt idx="2">
                    <c:v>2.4588941079218603</c:v>
                  </c:pt>
                  <c:pt idx="3">
                    <c:v>3.269797653162767</c:v>
                  </c:pt>
                  <c:pt idx="4">
                    <c:v>3.1231854450834753</c:v>
                  </c:pt>
                </c:numCache>
              </c:numRef>
            </c:minus>
          </c:errBars>
          <c:cat>
            <c:strRef>
              <c:f>'[Analysis-Differentiation-Brain NPCs-6-11-2017.xlsx]N=4'!$N$19:$N$23</c:f>
              <c:strCache>
                <c:ptCount val="5"/>
                <c:pt idx="0">
                  <c:v>Microglia Media</c:v>
                </c:pt>
                <c:pt idx="1">
                  <c:v>Incubated Nrg-1 50 </c:v>
                </c:pt>
                <c:pt idx="2">
                  <c:v>FreshNrg-1 50</c:v>
                </c:pt>
                <c:pt idx="3">
                  <c:v>Incubated Nrg-1 200 </c:v>
                </c:pt>
                <c:pt idx="4">
                  <c:v>Fresh Nrg-1 200</c:v>
                </c:pt>
              </c:strCache>
            </c:strRef>
          </c:cat>
          <c:val>
            <c:numRef>
              <c:f>'[Analysis-Differentiation-Brain NPCs-6-11-2017.xlsx]N=4'!$S$19:$S$23</c:f>
              <c:numCache>
                <c:formatCode>General</c:formatCode>
                <c:ptCount val="5"/>
                <c:pt idx="0">
                  <c:v>62.875770713792491</c:v>
                </c:pt>
                <c:pt idx="1">
                  <c:v>63.886870085724425</c:v>
                </c:pt>
                <c:pt idx="2">
                  <c:v>32.364549686556934</c:v>
                </c:pt>
                <c:pt idx="3">
                  <c:v>51.244998765985699</c:v>
                </c:pt>
                <c:pt idx="4">
                  <c:v>27.7828123782048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A69-4C54-A1B1-B805BD9818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17679200"/>
        <c:axId val="517678416"/>
      </c:barChart>
      <c:catAx>
        <c:axId val="5176792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">
                <a:noFill/>
              </a:defRPr>
            </a:pPr>
            <a:endParaRPr lang="en-US"/>
          </a:p>
        </c:txPr>
        <c:crossAx val="517678416"/>
        <c:crosses val="autoZero"/>
        <c:auto val="1"/>
        <c:lblAlgn val="ctr"/>
        <c:lblOffset val="100"/>
        <c:noMultiLvlLbl val="0"/>
      </c:catAx>
      <c:valAx>
        <c:axId val="517678416"/>
        <c:scaling>
          <c:orientation val="minMax"/>
          <c:max val="8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 b="1">
                <a:solidFill>
                  <a:sysClr val="windowText" lastClr="000000"/>
                </a:solidFill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517679200"/>
        <c:crosses val="autoZero"/>
        <c:crossBetween val="between"/>
        <c:majorUnit val="20"/>
        <c:min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817B45-D4D3-45CB-934D-97DF67DE9D2D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7588" y="1143000"/>
            <a:ext cx="22828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61A00-9F51-4288-915B-64876428B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1738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1pPr>
    <a:lvl2pPr marL="368046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2pPr>
    <a:lvl3pPr marL="736092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3pPr>
    <a:lvl4pPr marL="1104138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4pPr>
    <a:lvl5pPr marL="1472184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5pPr>
    <a:lvl6pPr marL="1840230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6pPr>
    <a:lvl7pPr marL="2208276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7pPr>
    <a:lvl8pPr marL="2576322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8pPr>
    <a:lvl9pPr marL="2944368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106" y="1384248"/>
            <a:ext cx="5316538" cy="2944707"/>
          </a:xfrm>
        </p:spPr>
        <p:txBody>
          <a:bodyPr anchor="b"/>
          <a:lstStyle>
            <a:lvl1pPr algn="ctr">
              <a:defRPr sz="4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1844" y="4442514"/>
            <a:ext cx="4691063" cy="2042106"/>
          </a:xfrm>
        </p:spPr>
        <p:txBody>
          <a:bodyPr/>
          <a:lstStyle>
            <a:lvl1pPr marL="0" indent="0" algn="ctr">
              <a:buNone/>
              <a:defRPr sz="1642"/>
            </a:lvl1pPr>
            <a:lvl2pPr marL="312725" indent="0" algn="ctr">
              <a:buNone/>
              <a:defRPr sz="1368"/>
            </a:lvl2pPr>
            <a:lvl3pPr marL="625450" indent="0" algn="ctr">
              <a:buNone/>
              <a:defRPr sz="1231"/>
            </a:lvl3pPr>
            <a:lvl4pPr marL="938174" indent="0" algn="ctr">
              <a:buNone/>
              <a:defRPr sz="1094"/>
            </a:lvl4pPr>
            <a:lvl5pPr marL="1250899" indent="0" algn="ctr">
              <a:buNone/>
              <a:defRPr sz="1094"/>
            </a:lvl5pPr>
            <a:lvl6pPr marL="1563624" indent="0" algn="ctr">
              <a:buNone/>
              <a:defRPr sz="1094"/>
            </a:lvl6pPr>
            <a:lvl7pPr marL="1876349" indent="0" algn="ctr">
              <a:buNone/>
              <a:defRPr sz="1094"/>
            </a:lvl7pPr>
            <a:lvl8pPr marL="2189074" indent="0" algn="ctr">
              <a:buNone/>
              <a:defRPr sz="1094"/>
            </a:lvl8pPr>
            <a:lvl9pPr marL="2501798" indent="0" algn="ctr">
              <a:buNone/>
              <a:defRPr sz="109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567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255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76056" y="450321"/>
            <a:ext cx="1348680" cy="71679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014" y="450321"/>
            <a:ext cx="3967857" cy="716793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92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468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6757" y="2108679"/>
            <a:ext cx="5394722" cy="3518376"/>
          </a:xfrm>
        </p:spPr>
        <p:txBody>
          <a:bodyPr anchor="b"/>
          <a:lstStyle>
            <a:lvl1pPr>
              <a:defRPr sz="4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6757" y="5660339"/>
            <a:ext cx="5394722" cy="1850231"/>
          </a:xfrm>
        </p:spPr>
        <p:txBody>
          <a:bodyPr/>
          <a:lstStyle>
            <a:lvl1pPr marL="0" indent="0">
              <a:buNone/>
              <a:defRPr sz="1642">
                <a:solidFill>
                  <a:schemeClr val="tx1"/>
                </a:solidFill>
              </a:defRPr>
            </a:lvl1pPr>
            <a:lvl2pPr marL="312725" indent="0">
              <a:buNone/>
              <a:defRPr sz="1368">
                <a:solidFill>
                  <a:schemeClr val="tx1">
                    <a:tint val="75000"/>
                  </a:schemeClr>
                </a:solidFill>
              </a:defRPr>
            </a:lvl2pPr>
            <a:lvl3pPr marL="625450" indent="0">
              <a:buNone/>
              <a:defRPr sz="1231">
                <a:solidFill>
                  <a:schemeClr val="tx1">
                    <a:tint val="75000"/>
                  </a:schemeClr>
                </a:solidFill>
              </a:defRPr>
            </a:lvl3pPr>
            <a:lvl4pPr marL="93817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4pPr>
            <a:lvl5pPr marL="1250899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5pPr>
            <a:lvl6pPr marL="156362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6pPr>
            <a:lvl7pPr marL="1876349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7pPr>
            <a:lvl8pPr marL="218907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8pPr>
            <a:lvl9pPr marL="2501798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533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014" y="2251604"/>
            <a:ext cx="2658269" cy="53666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66467" y="2251604"/>
            <a:ext cx="2658269" cy="53666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730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450323"/>
            <a:ext cx="5394722" cy="163486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829" y="2073434"/>
            <a:ext cx="2646052" cy="1016158"/>
          </a:xfrm>
        </p:spPr>
        <p:txBody>
          <a:bodyPr anchor="b"/>
          <a:lstStyle>
            <a:lvl1pPr marL="0" indent="0">
              <a:buNone/>
              <a:defRPr sz="1642" b="1"/>
            </a:lvl1pPr>
            <a:lvl2pPr marL="312725" indent="0">
              <a:buNone/>
              <a:defRPr sz="1368" b="1"/>
            </a:lvl2pPr>
            <a:lvl3pPr marL="625450" indent="0">
              <a:buNone/>
              <a:defRPr sz="1231" b="1"/>
            </a:lvl3pPr>
            <a:lvl4pPr marL="938174" indent="0">
              <a:buNone/>
              <a:defRPr sz="1094" b="1"/>
            </a:lvl4pPr>
            <a:lvl5pPr marL="1250899" indent="0">
              <a:buNone/>
              <a:defRPr sz="1094" b="1"/>
            </a:lvl5pPr>
            <a:lvl6pPr marL="1563624" indent="0">
              <a:buNone/>
              <a:defRPr sz="1094" b="1"/>
            </a:lvl6pPr>
            <a:lvl7pPr marL="1876349" indent="0">
              <a:buNone/>
              <a:defRPr sz="1094" b="1"/>
            </a:lvl7pPr>
            <a:lvl8pPr marL="2189074" indent="0">
              <a:buNone/>
              <a:defRPr sz="1094" b="1"/>
            </a:lvl8pPr>
            <a:lvl9pPr marL="2501798" indent="0">
              <a:buNone/>
              <a:defRPr sz="10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0829" y="3089593"/>
            <a:ext cx="2646052" cy="45443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66468" y="2073434"/>
            <a:ext cx="2659083" cy="1016158"/>
          </a:xfrm>
        </p:spPr>
        <p:txBody>
          <a:bodyPr anchor="b"/>
          <a:lstStyle>
            <a:lvl1pPr marL="0" indent="0">
              <a:buNone/>
              <a:defRPr sz="1642" b="1"/>
            </a:lvl1pPr>
            <a:lvl2pPr marL="312725" indent="0">
              <a:buNone/>
              <a:defRPr sz="1368" b="1"/>
            </a:lvl2pPr>
            <a:lvl3pPr marL="625450" indent="0">
              <a:buNone/>
              <a:defRPr sz="1231" b="1"/>
            </a:lvl3pPr>
            <a:lvl4pPr marL="938174" indent="0">
              <a:buNone/>
              <a:defRPr sz="1094" b="1"/>
            </a:lvl4pPr>
            <a:lvl5pPr marL="1250899" indent="0">
              <a:buNone/>
              <a:defRPr sz="1094" b="1"/>
            </a:lvl5pPr>
            <a:lvl6pPr marL="1563624" indent="0">
              <a:buNone/>
              <a:defRPr sz="1094" b="1"/>
            </a:lvl6pPr>
            <a:lvl7pPr marL="1876349" indent="0">
              <a:buNone/>
              <a:defRPr sz="1094" b="1"/>
            </a:lvl7pPr>
            <a:lvl8pPr marL="2189074" indent="0">
              <a:buNone/>
              <a:defRPr sz="1094" b="1"/>
            </a:lvl8pPr>
            <a:lvl9pPr marL="2501798" indent="0">
              <a:buNone/>
              <a:defRPr sz="10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66468" y="3089593"/>
            <a:ext cx="2659083" cy="45443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17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000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015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563880"/>
            <a:ext cx="2017320" cy="1973580"/>
          </a:xfrm>
        </p:spPr>
        <p:txBody>
          <a:bodyPr anchor="b"/>
          <a:lstStyle>
            <a:lvl1pPr>
              <a:defRPr sz="21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59084" y="1217826"/>
            <a:ext cx="3166467" cy="6010804"/>
          </a:xfrm>
        </p:spPr>
        <p:txBody>
          <a:bodyPr/>
          <a:lstStyle>
            <a:lvl1pPr>
              <a:defRPr sz="2189"/>
            </a:lvl1pPr>
            <a:lvl2pPr>
              <a:defRPr sz="1915"/>
            </a:lvl2pPr>
            <a:lvl3pPr>
              <a:defRPr sz="1642"/>
            </a:lvl3pPr>
            <a:lvl4pPr>
              <a:defRPr sz="1368"/>
            </a:lvl4pPr>
            <a:lvl5pPr>
              <a:defRPr sz="1368"/>
            </a:lvl5pPr>
            <a:lvl6pPr>
              <a:defRPr sz="1368"/>
            </a:lvl6pPr>
            <a:lvl7pPr>
              <a:defRPr sz="1368"/>
            </a:lvl7pPr>
            <a:lvl8pPr>
              <a:defRPr sz="1368"/>
            </a:lvl8pPr>
            <a:lvl9pPr>
              <a:defRPr sz="1368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0829" y="2537460"/>
            <a:ext cx="2017320" cy="4700959"/>
          </a:xfrm>
        </p:spPr>
        <p:txBody>
          <a:bodyPr/>
          <a:lstStyle>
            <a:lvl1pPr marL="0" indent="0">
              <a:buNone/>
              <a:defRPr sz="1094"/>
            </a:lvl1pPr>
            <a:lvl2pPr marL="312725" indent="0">
              <a:buNone/>
              <a:defRPr sz="958"/>
            </a:lvl2pPr>
            <a:lvl3pPr marL="625450" indent="0">
              <a:buNone/>
              <a:defRPr sz="821"/>
            </a:lvl3pPr>
            <a:lvl4pPr marL="938174" indent="0">
              <a:buNone/>
              <a:defRPr sz="684"/>
            </a:lvl4pPr>
            <a:lvl5pPr marL="1250899" indent="0">
              <a:buNone/>
              <a:defRPr sz="684"/>
            </a:lvl5pPr>
            <a:lvl6pPr marL="1563624" indent="0">
              <a:buNone/>
              <a:defRPr sz="684"/>
            </a:lvl6pPr>
            <a:lvl7pPr marL="1876349" indent="0">
              <a:buNone/>
              <a:defRPr sz="684"/>
            </a:lvl7pPr>
            <a:lvl8pPr marL="2189074" indent="0">
              <a:buNone/>
              <a:defRPr sz="684"/>
            </a:lvl8pPr>
            <a:lvl9pPr marL="2501798" indent="0">
              <a:buNone/>
              <a:defRPr sz="68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842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563880"/>
            <a:ext cx="2017320" cy="1973580"/>
          </a:xfrm>
        </p:spPr>
        <p:txBody>
          <a:bodyPr anchor="b"/>
          <a:lstStyle>
            <a:lvl1pPr>
              <a:defRPr sz="21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59084" y="1217826"/>
            <a:ext cx="3166467" cy="6010804"/>
          </a:xfrm>
        </p:spPr>
        <p:txBody>
          <a:bodyPr anchor="t"/>
          <a:lstStyle>
            <a:lvl1pPr marL="0" indent="0">
              <a:buNone/>
              <a:defRPr sz="2189"/>
            </a:lvl1pPr>
            <a:lvl2pPr marL="312725" indent="0">
              <a:buNone/>
              <a:defRPr sz="1915"/>
            </a:lvl2pPr>
            <a:lvl3pPr marL="625450" indent="0">
              <a:buNone/>
              <a:defRPr sz="1642"/>
            </a:lvl3pPr>
            <a:lvl4pPr marL="938174" indent="0">
              <a:buNone/>
              <a:defRPr sz="1368"/>
            </a:lvl4pPr>
            <a:lvl5pPr marL="1250899" indent="0">
              <a:buNone/>
              <a:defRPr sz="1368"/>
            </a:lvl5pPr>
            <a:lvl6pPr marL="1563624" indent="0">
              <a:buNone/>
              <a:defRPr sz="1368"/>
            </a:lvl6pPr>
            <a:lvl7pPr marL="1876349" indent="0">
              <a:buNone/>
              <a:defRPr sz="1368"/>
            </a:lvl7pPr>
            <a:lvl8pPr marL="2189074" indent="0">
              <a:buNone/>
              <a:defRPr sz="1368"/>
            </a:lvl8pPr>
            <a:lvl9pPr marL="2501798" indent="0">
              <a:buNone/>
              <a:defRPr sz="13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0829" y="2537460"/>
            <a:ext cx="2017320" cy="4700959"/>
          </a:xfrm>
        </p:spPr>
        <p:txBody>
          <a:bodyPr/>
          <a:lstStyle>
            <a:lvl1pPr marL="0" indent="0">
              <a:buNone/>
              <a:defRPr sz="1094"/>
            </a:lvl1pPr>
            <a:lvl2pPr marL="312725" indent="0">
              <a:buNone/>
              <a:defRPr sz="958"/>
            </a:lvl2pPr>
            <a:lvl3pPr marL="625450" indent="0">
              <a:buNone/>
              <a:defRPr sz="821"/>
            </a:lvl3pPr>
            <a:lvl4pPr marL="938174" indent="0">
              <a:buNone/>
              <a:defRPr sz="684"/>
            </a:lvl4pPr>
            <a:lvl5pPr marL="1250899" indent="0">
              <a:buNone/>
              <a:defRPr sz="684"/>
            </a:lvl5pPr>
            <a:lvl6pPr marL="1563624" indent="0">
              <a:buNone/>
              <a:defRPr sz="684"/>
            </a:lvl6pPr>
            <a:lvl7pPr marL="1876349" indent="0">
              <a:buNone/>
              <a:defRPr sz="684"/>
            </a:lvl7pPr>
            <a:lvl8pPr marL="2189074" indent="0">
              <a:buNone/>
              <a:defRPr sz="684"/>
            </a:lvl8pPr>
            <a:lvl9pPr marL="2501798" indent="0">
              <a:buNone/>
              <a:defRPr sz="68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3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014" y="450323"/>
            <a:ext cx="5394722" cy="1634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014" y="2251604"/>
            <a:ext cx="5394722" cy="53666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014" y="7839500"/>
            <a:ext cx="1407319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1886" y="7839500"/>
            <a:ext cx="2110978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17417" y="7839500"/>
            <a:ext cx="1407319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293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25450" rtl="0" eaLnBrk="1" latinLnBrk="0" hangingPunct="1">
        <a:lnSpc>
          <a:spcPct val="90000"/>
        </a:lnSpc>
        <a:spcBef>
          <a:spcPct val="0"/>
        </a:spcBef>
        <a:buNone/>
        <a:defRPr sz="30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362" indent="-156362" algn="l" defTabSz="625450" rtl="0" eaLnBrk="1" latinLnBrk="0" hangingPunct="1">
        <a:lnSpc>
          <a:spcPct val="90000"/>
        </a:lnSpc>
        <a:spcBef>
          <a:spcPts val="684"/>
        </a:spcBef>
        <a:buFont typeface="Arial" panose="020B0604020202020204" pitchFamily="34" charset="0"/>
        <a:buChar char="•"/>
        <a:defRPr sz="1915" kern="1200">
          <a:solidFill>
            <a:schemeClr val="tx1"/>
          </a:solidFill>
          <a:latin typeface="+mn-lt"/>
          <a:ea typeface="+mn-ea"/>
          <a:cs typeface="+mn-cs"/>
        </a:defRPr>
      </a:lvl1pPr>
      <a:lvl2pPr marL="469087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642" kern="1200">
          <a:solidFill>
            <a:schemeClr val="tx1"/>
          </a:solidFill>
          <a:latin typeface="+mn-lt"/>
          <a:ea typeface="+mn-ea"/>
          <a:cs typeface="+mn-cs"/>
        </a:defRPr>
      </a:lvl2pPr>
      <a:lvl3pPr marL="781812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368" kern="1200">
          <a:solidFill>
            <a:schemeClr val="tx1"/>
          </a:solidFill>
          <a:latin typeface="+mn-lt"/>
          <a:ea typeface="+mn-ea"/>
          <a:cs typeface="+mn-cs"/>
        </a:defRPr>
      </a:lvl3pPr>
      <a:lvl4pPr marL="1094537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4pPr>
      <a:lvl5pPr marL="1407262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5pPr>
      <a:lvl6pPr marL="1719986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6pPr>
      <a:lvl7pPr marL="2032711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7pPr>
      <a:lvl8pPr marL="2345436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8pPr>
      <a:lvl9pPr marL="2658161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1pPr>
      <a:lvl2pPr marL="312725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2pPr>
      <a:lvl3pPr marL="625450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3pPr>
      <a:lvl4pPr marL="93817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4pPr>
      <a:lvl5pPr marL="1250899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5pPr>
      <a:lvl6pPr marL="156362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6pPr>
      <a:lvl7pPr marL="1876349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7pPr>
      <a:lvl8pPr marL="218907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8pPr>
      <a:lvl9pPr marL="2501798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chart" Target="../charts/chart3.xm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extBox 107"/>
          <p:cNvSpPr txBox="1"/>
          <p:nvPr/>
        </p:nvSpPr>
        <p:spPr>
          <a:xfrm>
            <a:off x="62970" y="56200"/>
            <a:ext cx="28841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Shahriary et al.- Supplementary Figure 4</a:t>
            </a:r>
          </a:p>
        </p:txBody>
      </p:sp>
      <p:sp>
        <p:nvSpPr>
          <p:cNvPr id="97" name="TextBox 96"/>
          <p:cNvSpPr txBox="1"/>
          <p:nvPr/>
        </p:nvSpPr>
        <p:spPr>
          <a:xfrm rot="16200000">
            <a:off x="2041936" y="1611226"/>
            <a:ext cx="9156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 err="1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rdU</a:t>
            </a:r>
            <a:r>
              <a:rPr lang="en-CA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+ </a:t>
            </a:r>
            <a:r>
              <a:rPr lang="en-CA" sz="1000" b="1" dirty="0">
                <a:solidFill>
                  <a:srgbClr val="0070C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API</a:t>
            </a:r>
          </a:p>
        </p:txBody>
      </p:sp>
      <p:sp>
        <p:nvSpPr>
          <p:cNvPr id="98" name="TextBox 97"/>
          <p:cNvSpPr txBox="1"/>
          <p:nvPr/>
        </p:nvSpPr>
        <p:spPr>
          <a:xfrm rot="16200000">
            <a:off x="2049202" y="2569598"/>
            <a:ext cx="9156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 err="1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rdU</a:t>
            </a:r>
            <a:r>
              <a:rPr lang="en-CA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+ </a:t>
            </a:r>
            <a:r>
              <a:rPr lang="en-CA" sz="1000" b="1" dirty="0">
                <a:solidFill>
                  <a:srgbClr val="0070C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API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497844" y="360891"/>
            <a:ext cx="4024032" cy="1064816"/>
            <a:chOff x="497844" y="360891"/>
            <a:chExt cx="4024032" cy="1064816"/>
          </a:xfrm>
        </p:grpSpPr>
        <p:sp>
          <p:nvSpPr>
            <p:cNvPr id="119" name="TextBox 118"/>
            <p:cNvSpPr txBox="1"/>
            <p:nvPr/>
          </p:nvSpPr>
          <p:spPr>
            <a:xfrm>
              <a:off x="670921" y="575568"/>
              <a:ext cx="17075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Nrg-1 50 ng/ml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670435" y="767833"/>
              <a:ext cx="14590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Fresh Nrg-1 50 ng/ml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670280" y="956016"/>
              <a:ext cx="178286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Nrg-1 200 ng/ml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670280" y="1171791"/>
              <a:ext cx="153439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Fresh Nrg-1 200 ng/ml</a:t>
              </a:r>
            </a:p>
          </p:txBody>
        </p:sp>
        <p:sp>
          <p:nvSpPr>
            <p:cNvPr id="123" name="Rectangle 122"/>
            <p:cNvSpPr/>
            <p:nvPr/>
          </p:nvSpPr>
          <p:spPr>
            <a:xfrm>
              <a:off x="498918" y="648448"/>
              <a:ext cx="203586" cy="126137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05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05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124" name="Rectangle 123"/>
            <p:cNvSpPr/>
            <p:nvPr/>
          </p:nvSpPr>
          <p:spPr>
            <a:xfrm>
              <a:off x="498821" y="1037549"/>
              <a:ext cx="203586" cy="126137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05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05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125" name="Rectangle 124"/>
            <p:cNvSpPr/>
            <p:nvPr/>
          </p:nvSpPr>
          <p:spPr>
            <a:xfrm>
              <a:off x="498650" y="438375"/>
              <a:ext cx="203586" cy="126137"/>
            </a:xfrm>
            <a:prstGeom prst="rect">
              <a:avLst/>
            </a:prstGeom>
            <a:solidFill>
              <a:srgbClr val="C0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05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05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126" name="TextBox 88"/>
            <p:cNvSpPr txBox="1"/>
            <p:nvPr/>
          </p:nvSpPr>
          <p:spPr>
            <a:xfrm>
              <a:off x="670920" y="374749"/>
              <a:ext cx="15840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Control media</a:t>
              </a:r>
              <a:endParaRPr lang="en-US" sz="1050" dirty="0"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sp>
          <p:nvSpPr>
            <p:cNvPr id="127" name="Rectangle 126"/>
            <p:cNvSpPr/>
            <p:nvPr/>
          </p:nvSpPr>
          <p:spPr>
            <a:xfrm>
              <a:off x="497844" y="838168"/>
              <a:ext cx="203586" cy="126137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05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05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128" name="Rectangle 127"/>
            <p:cNvSpPr/>
            <p:nvPr/>
          </p:nvSpPr>
          <p:spPr>
            <a:xfrm>
              <a:off x="501566" y="1238434"/>
              <a:ext cx="203586" cy="126137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05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05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129" name="Rectangle 128"/>
            <p:cNvSpPr/>
            <p:nvPr/>
          </p:nvSpPr>
          <p:spPr>
            <a:xfrm>
              <a:off x="2705500" y="438252"/>
              <a:ext cx="203586" cy="126137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05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05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2878477" y="360891"/>
              <a:ext cx="164339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IFN-</a:t>
              </a:r>
              <a:r>
                <a:rPr lang="el-GR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γ</a:t>
              </a:r>
              <a:r>
                <a:rPr lang="en-US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+ TNF-</a:t>
              </a:r>
              <a:r>
                <a:rPr lang="el-GR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endParaRPr lang="en-US" sz="10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2878477" y="564051"/>
              <a:ext cx="139493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Fresh IFN-</a:t>
              </a:r>
              <a:r>
                <a:rPr lang="el-GR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γ</a:t>
              </a:r>
              <a:r>
                <a:rPr lang="en-US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+ TNF-</a:t>
              </a:r>
              <a:r>
                <a:rPr lang="el-GR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endParaRPr lang="en-US" sz="10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" name="Rectangle 135"/>
            <p:cNvSpPr/>
            <p:nvPr/>
          </p:nvSpPr>
          <p:spPr>
            <a:xfrm>
              <a:off x="2703999" y="617811"/>
              <a:ext cx="203586" cy="126137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05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05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2485962" y="1067735"/>
            <a:ext cx="3807166" cy="1977603"/>
            <a:chOff x="2485962" y="1067735"/>
            <a:chExt cx="3807166" cy="1977603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90994" y="1401320"/>
              <a:ext cx="3638995" cy="1644018"/>
            </a:xfrm>
            <a:prstGeom prst="rect">
              <a:avLst/>
            </a:prstGeom>
          </p:spPr>
        </p:pic>
        <p:sp>
          <p:nvSpPr>
            <p:cNvPr id="114" name="TextBox 113"/>
            <p:cNvSpPr txBox="1"/>
            <p:nvPr/>
          </p:nvSpPr>
          <p:spPr>
            <a:xfrm>
              <a:off x="2532075" y="1214712"/>
              <a:ext cx="9605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ontrol media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3414470" y="1069911"/>
              <a:ext cx="9861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50 ng/ml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4345415" y="1067735"/>
              <a:ext cx="9861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Fresh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50 ng/ml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2485962" y="2029486"/>
              <a:ext cx="1050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Fresh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200 ng/ml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5242840" y="1070999"/>
              <a:ext cx="1050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200 ng/ml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3497090" y="2015825"/>
              <a:ext cx="9060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FN-</a:t>
              </a:r>
              <a:r>
                <a:rPr lang="el-GR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γ</a:t>
              </a:r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+ TNF-</a:t>
              </a:r>
              <a:r>
                <a:rPr lang="el-GR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endParaRPr lang="en-US" sz="9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4402901" y="2018915"/>
              <a:ext cx="9060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Fresh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FN-</a:t>
              </a:r>
              <a:r>
                <a:rPr lang="el-GR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γ</a:t>
              </a:r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+ TNF-</a:t>
              </a:r>
              <a:r>
                <a:rPr lang="el-GR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endParaRPr lang="en-US" sz="9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2570015" y="1392867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3476347" y="1389062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c</a:t>
              </a: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395832" y="1395748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</a:t>
              </a: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5297370" y="1381083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e</a:t>
              </a: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2565509" y="2357101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f</a:t>
              </a:r>
            </a:p>
          </p:txBody>
        </p:sp>
        <p:sp>
          <p:nvSpPr>
            <p:cNvPr id="147" name="TextBox 146"/>
            <p:cNvSpPr txBox="1"/>
            <p:nvPr/>
          </p:nvSpPr>
          <p:spPr>
            <a:xfrm flipH="1">
              <a:off x="3455253" y="2330773"/>
              <a:ext cx="3119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g</a:t>
              </a: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4396691" y="2356411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h</a:t>
              </a: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2468659" y="3183443"/>
            <a:ext cx="3533596" cy="2560867"/>
            <a:chOff x="6692647" y="2997593"/>
            <a:chExt cx="3533596" cy="2560867"/>
          </a:xfrm>
        </p:grpSpPr>
        <p:sp>
          <p:nvSpPr>
            <p:cNvPr id="95" name="TextBox 94"/>
            <p:cNvSpPr txBox="1"/>
            <p:nvPr/>
          </p:nvSpPr>
          <p:spPr>
            <a:xfrm rot="16200000">
              <a:off x="6215409" y="3662423"/>
              <a:ext cx="12006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FF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GFAP</a:t>
              </a: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0070C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API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 rot="16200000">
              <a:off x="6237712" y="4835000"/>
              <a:ext cx="12006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FF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GFAP</a:t>
              </a: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0070C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API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6977547" y="3145327"/>
              <a:ext cx="9605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ontrol media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8111939" y="3000518"/>
              <a:ext cx="9861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50 ng/ml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9211724" y="2997593"/>
              <a:ext cx="9861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Fresh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50 ng/ml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8079878" y="4209024"/>
              <a:ext cx="1050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Fresh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200 ng/ml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6977547" y="4210157"/>
              <a:ext cx="1050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200 ng/ml</a:t>
              </a: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929522" y="3346739"/>
              <a:ext cx="3296721" cy="2052826"/>
            </a:xfrm>
            <a:prstGeom prst="rect">
              <a:avLst/>
            </a:prstGeom>
          </p:spPr>
        </p:pic>
        <p:sp>
          <p:nvSpPr>
            <p:cNvPr id="149" name="TextBox 148"/>
            <p:cNvSpPr txBox="1"/>
            <p:nvPr/>
          </p:nvSpPr>
          <p:spPr>
            <a:xfrm>
              <a:off x="6938869" y="3335182"/>
              <a:ext cx="2199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j</a:t>
              </a: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8079878" y="333745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</a:t>
              </a: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9170242" y="3335449"/>
              <a:ext cx="2199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l</a:t>
              </a: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6911704" y="4520602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8063473" y="4520602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n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2518618" y="5607854"/>
            <a:ext cx="3520837" cy="2512532"/>
            <a:chOff x="2518618" y="5607854"/>
            <a:chExt cx="3520837" cy="2512532"/>
          </a:xfrm>
        </p:grpSpPr>
        <p:sp>
          <p:nvSpPr>
            <p:cNvPr id="105" name="TextBox 104"/>
            <p:cNvSpPr txBox="1"/>
            <p:nvPr/>
          </p:nvSpPr>
          <p:spPr>
            <a:xfrm>
              <a:off x="2806624" y="6837064"/>
              <a:ext cx="1050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200 ng/ml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2815319" y="5764836"/>
              <a:ext cx="9605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ontrol media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3917784" y="5623686"/>
              <a:ext cx="9861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50 ng/ml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990925" y="5607854"/>
              <a:ext cx="9861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Fresh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50 ng/ml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3794709" y="6834118"/>
              <a:ext cx="12260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Fresh</a:t>
              </a:r>
            </a:p>
            <a:p>
              <a:pPr algn="ctr"/>
              <a:r>
                <a:rPr lang="en-US" sz="9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rg-1 200 ng/ml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 rot="16200000">
              <a:off x="2101365" y="6266751"/>
              <a:ext cx="1080727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FF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NG2</a:t>
              </a:r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0070C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API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 rot="16200000">
              <a:off x="2109295" y="7456912"/>
              <a:ext cx="1080727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FF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NG2</a:t>
              </a:r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0070C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API</a:t>
              </a:r>
            </a:p>
          </p:txBody>
        </p:sp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30267" y="5967247"/>
              <a:ext cx="3309188" cy="2069211"/>
            </a:xfrm>
            <a:prstGeom prst="rect">
              <a:avLst/>
            </a:prstGeom>
          </p:spPr>
        </p:pic>
        <p:sp>
          <p:nvSpPr>
            <p:cNvPr id="154" name="TextBox 153"/>
            <p:cNvSpPr txBox="1"/>
            <p:nvPr/>
          </p:nvSpPr>
          <p:spPr>
            <a:xfrm>
              <a:off x="2730924" y="5977186"/>
              <a:ext cx="3032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</a:t>
              </a: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3878818" y="5963201"/>
              <a:ext cx="3032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q</a:t>
              </a: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4948586" y="5933376"/>
              <a:ext cx="283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r</a:t>
              </a: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2712687" y="7162333"/>
              <a:ext cx="3032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s</a:t>
              </a: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3888757" y="7172272"/>
              <a:ext cx="3032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t</a:t>
              </a: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-31927" y="5825796"/>
            <a:ext cx="2659680" cy="2275855"/>
            <a:chOff x="-31927" y="5940096"/>
            <a:chExt cx="2659680" cy="2275855"/>
          </a:xfrm>
        </p:grpSpPr>
        <p:sp>
          <p:nvSpPr>
            <p:cNvPr id="44" name="TextBox 43"/>
            <p:cNvSpPr txBox="1"/>
            <p:nvPr/>
          </p:nvSpPr>
          <p:spPr>
            <a:xfrm rot="16200000">
              <a:off x="-696903" y="6963365"/>
              <a:ext cx="210506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Proportion of NG2+/DAPI+ cells</a:t>
              </a:r>
            </a:p>
            <a:p>
              <a:pPr algn="ctr"/>
              <a:r>
                <a:rPr lang="en-CA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ormalized to control media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-31927" y="5940096"/>
              <a:ext cx="3642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o)</a:t>
              </a:r>
            </a:p>
          </p:txBody>
        </p:sp>
        <p:graphicFrame>
          <p:nvGraphicFramePr>
            <p:cNvPr id="42" name="Chart 4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83168887"/>
                </p:ext>
              </p:extLst>
            </p:nvPr>
          </p:nvGraphicFramePr>
          <p:xfrm>
            <a:off x="495667" y="6286565"/>
            <a:ext cx="2132086" cy="15408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45" name="Group 44"/>
            <p:cNvGrpSpPr/>
            <p:nvPr/>
          </p:nvGrpSpPr>
          <p:grpSpPr>
            <a:xfrm>
              <a:off x="1326216" y="6515677"/>
              <a:ext cx="339468" cy="188534"/>
              <a:chOff x="755472" y="288495"/>
              <a:chExt cx="1911528" cy="321106"/>
            </a:xfrm>
          </p:grpSpPr>
          <p:grpSp>
            <p:nvGrpSpPr>
              <p:cNvPr id="88" name="Group 87"/>
              <p:cNvGrpSpPr/>
              <p:nvPr/>
            </p:nvGrpSpPr>
            <p:grpSpPr>
              <a:xfrm>
                <a:off x="914400" y="533401"/>
                <a:ext cx="1752600" cy="76200"/>
                <a:chOff x="914400" y="762000"/>
                <a:chExt cx="1752600" cy="76200"/>
              </a:xfrm>
            </p:grpSpPr>
            <p:cxnSp>
              <p:nvCxnSpPr>
                <p:cNvPr id="90" name="Straight Connector 89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Straight Connector 90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Straight Connector 91"/>
                <p:cNvCxnSpPr/>
                <p:nvPr/>
              </p:nvCxnSpPr>
              <p:spPr>
                <a:xfrm>
                  <a:off x="26670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9" name="TextBox 3"/>
              <p:cNvSpPr txBox="1"/>
              <p:nvPr/>
            </p:nvSpPr>
            <p:spPr>
              <a:xfrm>
                <a:off x="755472" y="288495"/>
                <a:ext cx="1234175" cy="190502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46" name="Group 45"/>
            <p:cNvGrpSpPr/>
            <p:nvPr/>
          </p:nvGrpSpPr>
          <p:grpSpPr>
            <a:xfrm>
              <a:off x="1972332" y="6435315"/>
              <a:ext cx="328672" cy="187825"/>
              <a:chOff x="875965" y="297453"/>
              <a:chExt cx="1791034" cy="312147"/>
            </a:xfrm>
          </p:grpSpPr>
          <p:grpSp>
            <p:nvGrpSpPr>
              <p:cNvPr id="83" name="Group 82"/>
              <p:cNvGrpSpPr/>
              <p:nvPr/>
            </p:nvGrpSpPr>
            <p:grpSpPr>
              <a:xfrm>
                <a:off x="914399" y="533400"/>
                <a:ext cx="1752600" cy="76200"/>
                <a:chOff x="914400" y="762000"/>
                <a:chExt cx="1752600" cy="76200"/>
              </a:xfrm>
            </p:grpSpPr>
            <p:cxnSp>
              <p:nvCxnSpPr>
                <p:cNvPr id="85" name="Straight Connector 84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Straight Connector 85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Straight Connector 86"/>
                <p:cNvCxnSpPr/>
                <p:nvPr/>
              </p:nvCxnSpPr>
              <p:spPr>
                <a:xfrm>
                  <a:off x="26670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4" name="TextBox 3"/>
              <p:cNvSpPr txBox="1"/>
              <p:nvPr/>
            </p:nvSpPr>
            <p:spPr>
              <a:xfrm>
                <a:off x="875965" y="297453"/>
                <a:ext cx="1234170" cy="190501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160" name="Group 159"/>
            <p:cNvGrpSpPr/>
            <p:nvPr/>
          </p:nvGrpSpPr>
          <p:grpSpPr>
            <a:xfrm>
              <a:off x="985807" y="6446967"/>
              <a:ext cx="669283" cy="51398"/>
              <a:chOff x="914400" y="762000"/>
              <a:chExt cx="1752600" cy="76200"/>
            </a:xfrm>
          </p:grpSpPr>
          <p:cxnSp>
            <p:nvCxnSpPr>
              <p:cNvPr id="162" name="Straight Connector 161"/>
              <p:cNvCxnSpPr/>
              <p:nvPr/>
            </p:nvCxnSpPr>
            <p:spPr>
              <a:xfrm>
                <a:off x="914400" y="762000"/>
                <a:ext cx="17526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Straight Connector 162"/>
              <p:cNvCxnSpPr/>
              <p:nvPr/>
            </p:nvCxnSpPr>
            <p:spPr>
              <a:xfrm>
                <a:off x="914400" y="762000"/>
                <a:ext cx="0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/>
              <p:cNvCxnSpPr/>
              <p:nvPr/>
            </p:nvCxnSpPr>
            <p:spPr>
              <a:xfrm>
                <a:off x="2667000" y="762000"/>
                <a:ext cx="0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5" name="Group 164"/>
            <p:cNvGrpSpPr/>
            <p:nvPr/>
          </p:nvGrpSpPr>
          <p:grpSpPr>
            <a:xfrm>
              <a:off x="985807" y="6265747"/>
              <a:ext cx="1372507" cy="192370"/>
              <a:chOff x="914400" y="280644"/>
              <a:chExt cx="1832357" cy="328957"/>
            </a:xfrm>
          </p:grpSpPr>
          <p:grpSp>
            <p:nvGrpSpPr>
              <p:cNvPr id="166" name="Group 165"/>
              <p:cNvGrpSpPr/>
              <p:nvPr/>
            </p:nvGrpSpPr>
            <p:grpSpPr>
              <a:xfrm>
                <a:off x="914400" y="533401"/>
                <a:ext cx="1752600" cy="76200"/>
                <a:chOff x="914400" y="762000"/>
                <a:chExt cx="1752600" cy="76200"/>
              </a:xfrm>
            </p:grpSpPr>
            <p:cxnSp>
              <p:nvCxnSpPr>
                <p:cNvPr id="168" name="Straight Connector 167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9" name="Straight Connector 168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0" name="Straight Connector 169"/>
                <p:cNvCxnSpPr/>
                <p:nvPr/>
              </p:nvCxnSpPr>
              <p:spPr>
                <a:xfrm>
                  <a:off x="26670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7" name="TextBox 3"/>
              <p:cNvSpPr txBox="1"/>
              <p:nvPr/>
            </p:nvSpPr>
            <p:spPr>
              <a:xfrm>
                <a:off x="1512585" y="280644"/>
                <a:ext cx="1234172" cy="190502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*</a:t>
                </a:r>
              </a:p>
            </p:txBody>
          </p:sp>
        </p:grpSp>
      </p:grpSp>
      <p:grpSp>
        <p:nvGrpSpPr>
          <p:cNvPr id="24" name="Group 23"/>
          <p:cNvGrpSpPr/>
          <p:nvPr/>
        </p:nvGrpSpPr>
        <p:grpSpPr>
          <a:xfrm>
            <a:off x="-12955" y="1056257"/>
            <a:ext cx="2558744" cy="2594367"/>
            <a:chOff x="-12955" y="1056257"/>
            <a:chExt cx="2558744" cy="2594367"/>
          </a:xfrm>
        </p:grpSpPr>
        <p:grpSp>
          <p:nvGrpSpPr>
            <p:cNvPr id="171" name="Group 170"/>
            <p:cNvGrpSpPr/>
            <p:nvPr/>
          </p:nvGrpSpPr>
          <p:grpSpPr>
            <a:xfrm>
              <a:off x="648600" y="1489775"/>
              <a:ext cx="1897189" cy="211052"/>
              <a:chOff x="914400" y="354432"/>
              <a:chExt cx="2011708" cy="255169"/>
            </a:xfrm>
          </p:grpSpPr>
          <p:grpSp>
            <p:nvGrpSpPr>
              <p:cNvPr id="172" name="Group 171"/>
              <p:cNvGrpSpPr/>
              <p:nvPr/>
            </p:nvGrpSpPr>
            <p:grpSpPr>
              <a:xfrm>
                <a:off x="914400" y="533401"/>
                <a:ext cx="1752601" cy="76200"/>
                <a:chOff x="914400" y="762000"/>
                <a:chExt cx="1752600" cy="76200"/>
              </a:xfrm>
            </p:grpSpPr>
            <p:cxnSp>
              <p:nvCxnSpPr>
                <p:cNvPr id="174" name="Straight Connector 173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5" name="Straight Connector 174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6" name="Straight Connector 175"/>
                <p:cNvCxnSpPr/>
                <p:nvPr/>
              </p:nvCxnSpPr>
              <p:spPr>
                <a:xfrm>
                  <a:off x="2665889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3" name="TextBox 3"/>
              <p:cNvSpPr txBox="1"/>
              <p:nvPr/>
            </p:nvSpPr>
            <p:spPr>
              <a:xfrm>
                <a:off x="1528475" y="354432"/>
                <a:ext cx="1397633" cy="221711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*</a:t>
                </a:r>
              </a:p>
            </p:txBody>
          </p:sp>
        </p:grpSp>
        <p:graphicFrame>
          <p:nvGraphicFramePr>
            <p:cNvPr id="137" name="Chart 13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67851385"/>
                </p:ext>
              </p:extLst>
            </p:nvPr>
          </p:nvGraphicFramePr>
          <p:xfrm>
            <a:off x="185351" y="1502531"/>
            <a:ext cx="2339819" cy="16029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cxnSp>
          <p:nvCxnSpPr>
            <p:cNvPr id="25" name="Straight Connector 24"/>
            <p:cNvCxnSpPr/>
            <p:nvPr/>
          </p:nvCxnSpPr>
          <p:spPr>
            <a:xfrm>
              <a:off x="650643" y="1708814"/>
              <a:ext cx="53290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648204" y="1698252"/>
              <a:ext cx="0" cy="6855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1185564" y="1708814"/>
              <a:ext cx="0" cy="6855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" name="Group 7"/>
            <p:cNvGrpSpPr/>
            <p:nvPr/>
          </p:nvGrpSpPr>
          <p:grpSpPr>
            <a:xfrm>
              <a:off x="826674" y="1894266"/>
              <a:ext cx="439438" cy="334710"/>
              <a:chOff x="543288" y="292443"/>
              <a:chExt cx="2985241" cy="544492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914400" y="533401"/>
                <a:ext cx="1752601" cy="76200"/>
                <a:chOff x="914400" y="762000"/>
                <a:chExt cx="1752600" cy="76200"/>
              </a:xfrm>
            </p:grpSpPr>
            <p:cxnSp>
              <p:nvCxnSpPr>
                <p:cNvPr id="18" name="Straight Connector 17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/>
                <p:cNvCxnSpPr/>
                <p:nvPr/>
              </p:nvCxnSpPr>
              <p:spPr>
                <a:xfrm>
                  <a:off x="2661921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" name="TextBox 3"/>
              <p:cNvSpPr txBox="1"/>
              <p:nvPr/>
            </p:nvSpPr>
            <p:spPr>
              <a:xfrm>
                <a:off x="543288" y="292443"/>
                <a:ext cx="2985241" cy="544492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1366961" y="1883553"/>
              <a:ext cx="311336" cy="195830"/>
              <a:chOff x="486101" y="201811"/>
              <a:chExt cx="2180900" cy="417494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914400" y="533401"/>
                <a:ext cx="1752601" cy="76200"/>
                <a:chOff x="914400" y="762000"/>
                <a:chExt cx="1752600" cy="76200"/>
              </a:xfrm>
            </p:grpSpPr>
            <p:cxnSp>
              <p:nvCxnSpPr>
                <p:cNvPr id="13" name="Straight Connector 12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/>
                <p:cNvCxnSpPr/>
                <p:nvPr/>
              </p:nvCxnSpPr>
              <p:spPr>
                <a:xfrm>
                  <a:off x="2661921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" name="TextBox 3"/>
              <p:cNvSpPr txBox="1"/>
              <p:nvPr/>
            </p:nvSpPr>
            <p:spPr>
              <a:xfrm>
                <a:off x="486101" y="201811"/>
                <a:ext cx="1298182" cy="417494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</a:t>
                </a: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 rot="16200000">
              <a:off x="-1143563" y="2230330"/>
              <a:ext cx="25943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% of BrdU+ to DAPI+ cells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-12955" y="1253438"/>
              <a:ext cx="3567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a)</a:t>
              </a:r>
            </a:p>
          </p:txBody>
        </p:sp>
        <p:grpSp>
          <p:nvGrpSpPr>
            <p:cNvPr id="139" name="Group 138"/>
            <p:cNvGrpSpPr/>
            <p:nvPr/>
          </p:nvGrpSpPr>
          <p:grpSpPr>
            <a:xfrm>
              <a:off x="1919286" y="2030611"/>
              <a:ext cx="330039" cy="195830"/>
              <a:chOff x="276204" y="244484"/>
              <a:chExt cx="2390797" cy="417494"/>
            </a:xfrm>
          </p:grpSpPr>
          <p:grpSp>
            <p:nvGrpSpPr>
              <p:cNvPr id="140" name="Group 139"/>
              <p:cNvGrpSpPr/>
              <p:nvPr/>
            </p:nvGrpSpPr>
            <p:grpSpPr>
              <a:xfrm>
                <a:off x="914400" y="533401"/>
                <a:ext cx="1752601" cy="76200"/>
                <a:chOff x="914400" y="762000"/>
                <a:chExt cx="1752600" cy="76200"/>
              </a:xfrm>
            </p:grpSpPr>
            <p:cxnSp>
              <p:nvCxnSpPr>
                <p:cNvPr id="142" name="Straight Connector 141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3" name="Straight Connector 142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Straight Connector 143"/>
                <p:cNvCxnSpPr/>
                <p:nvPr/>
              </p:nvCxnSpPr>
              <p:spPr>
                <a:xfrm>
                  <a:off x="2661921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1" name="TextBox 3"/>
              <p:cNvSpPr txBox="1"/>
              <p:nvPr/>
            </p:nvSpPr>
            <p:spPr>
              <a:xfrm>
                <a:off x="276204" y="244484"/>
                <a:ext cx="1298180" cy="417494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77" name="Group 176"/>
            <p:cNvGrpSpPr/>
            <p:nvPr/>
          </p:nvGrpSpPr>
          <p:grpSpPr>
            <a:xfrm>
              <a:off x="654607" y="1674248"/>
              <a:ext cx="1058568" cy="45719"/>
              <a:chOff x="935336" y="762000"/>
              <a:chExt cx="1752599" cy="76200"/>
            </a:xfrm>
          </p:grpSpPr>
          <p:cxnSp>
            <p:nvCxnSpPr>
              <p:cNvPr id="178" name="Straight Connector 177"/>
              <p:cNvCxnSpPr/>
              <p:nvPr/>
            </p:nvCxnSpPr>
            <p:spPr>
              <a:xfrm>
                <a:off x="935336" y="762000"/>
                <a:ext cx="17525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Straight Connector 179"/>
              <p:cNvCxnSpPr/>
              <p:nvPr/>
            </p:nvCxnSpPr>
            <p:spPr>
              <a:xfrm>
                <a:off x="2685469" y="762000"/>
                <a:ext cx="0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" name="Group 3"/>
          <p:cNvGrpSpPr/>
          <p:nvPr/>
        </p:nvGrpSpPr>
        <p:grpSpPr>
          <a:xfrm>
            <a:off x="23743" y="3323917"/>
            <a:ext cx="2373669" cy="2410989"/>
            <a:chOff x="23743" y="3323917"/>
            <a:chExt cx="2373669" cy="2410989"/>
          </a:xfrm>
        </p:grpSpPr>
        <p:sp>
          <p:nvSpPr>
            <p:cNvPr id="50" name="TextBox 49"/>
            <p:cNvSpPr txBox="1"/>
            <p:nvPr/>
          </p:nvSpPr>
          <p:spPr>
            <a:xfrm rot="16200000">
              <a:off x="-724355" y="4435832"/>
              <a:ext cx="219803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Proportion of GFAP+/DAPI+ cells</a:t>
              </a:r>
            </a:p>
            <a:p>
              <a:pPr algn="ctr"/>
              <a:r>
                <a:rPr lang="en-CA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ormalized to control media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3743" y="3323917"/>
              <a:ext cx="5122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</a:t>
              </a:r>
              <a:r>
                <a:rPr lang="en-US" sz="1100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</a:t>
              </a:r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</p:txBody>
        </p:sp>
        <p:graphicFrame>
          <p:nvGraphicFramePr>
            <p:cNvPr id="43" name="Chart 4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00329463"/>
                </p:ext>
              </p:extLst>
            </p:nvPr>
          </p:nvGraphicFramePr>
          <p:xfrm>
            <a:off x="572153" y="3862523"/>
            <a:ext cx="1825259" cy="17105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51" name="Group 50"/>
            <p:cNvGrpSpPr/>
            <p:nvPr/>
          </p:nvGrpSpPr>
          <p:grpSpPr>
            <a:xfrm>
              <a:off x="1325174" y="4499935"/>
              <a:ext cx="315048" cy="178281"/>
              <a:chOff x="573993" y="307660"/>
              <a:chExt cx="2093008" cy="301941"/>
            </a:xfrm>
          </p:grpSpPr>
          <p:grpSp>
            <p:nvGrpSpPr>
              <p:cNvPr id="66" name="Group 65"/>
              <p:cNvGrpSpPr/>
              <p:nvPr/>
            </p:nvGrpSpPr>
            <p:grpSpPr>
              <a:xfrm>
                <a:off x="914400" y="533401"/>
                <a:ext cx="1752601" cy="76200"/>
                <a:chOff x="914400" y="762000"/>
                <a:chExt cx="1752600" cy="76200"/>
              </a:xfrm>
            </p:grpSpPr>
            <p:cxnSp>
              <p:nvCxnSpPr>
                <p:cNvPr id="68" name="Straight Connector 67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Straight Connector 68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Straight Connector 69"/>
                <p:cNvCxnSpPr/>
                <p:nvPr/>
              </p:nvCxnSpPr>
              <p:spPr>
                <a:xfrm>
                  <a:off x="26670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7" name="TextBox 3"/>
              <p:cNvSpPr txBox="1"/>
              <p:nvPr/>
            </p:nvSpPr>
            <p:spPr>
              <a:xfrm>
                <a:off x="573993" y="307660"/>
                <a:ext cx="1663761" cy="270209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52" name="Group 51"/>
            <p:cNvGrpSpPr/>
            <p:nvPr/>
          </p:nvGrpSpPr>
          <p:grpSpPr>
            <a:xfrm>
              <a:off x="1911559" y="4215281"/>
              <a:ext cx="339810" cy="246072"/>
              <a:chOff x="687912" y="266504"/>
              <a:chExt cx="1979089" cy="450492"/>
            </a:xfrm>
          </p:grpSpPr>
          <p:grpSp>
            <p:nvGrpSpPr>
              <p:cNvPr id="61" name="Group 60"/>
              <p:cNvGrpSpPr/>
              <p:nvPr/>
            </p:nvGrpSpPr>
            <p:grpSpPr>
              <a:xfrm>
                <a:off x="914400" y="533401"/>
                <a:ext cx="1752601" cy="76200"/>
                <a:chOff x="914400" y="762000"/>
                <a:chExt cx="1752600" cy="76200"/>
              </a:xfrm>
            </p:grpSpPr>
            <p:cxnSp>
              <p:nvCxnSpPr>
                <p:cNvPr id="63" name="Straight Connector 62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Straight Connector 63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Straight Connector 64"/>
                <p:cNvCxnSpPr/>
                <p:nvPr/>
              </p:nvCxnSpPr>
              <p:spPr>
                <a:xfrm>
                  <a:off x="2648147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2" name="TextBox 3"/>
              <p:cNvSpPr txBox="1"/>
              <p:nvPr/>
            </p:nvSpPr>
            <p:spPr>
              <a:xfrm>
                <a:off x="687912" y="266504"/>
                <a:ext cx="1234174" cy="450492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71" name="Group 70"/>
            <p:cNvGrpSpPr/>
            <p:nvPr/>
          </p:nvGrpSpPr>
          <p:grpSpPr>
            <a:xfrm>
              <a:off x="1010953" y="4026290"/>
              <a:ext cx="1244212" cy="59439"/>
              <a:chOff x="914400" y="760823"/>
              <a:chExt cx="1752600" cy="62975"/>
            </a:xfrm>
          </p:grpSpPr>
          <p:cxnSp>
            <p:nvCxnSpPr>
              <p:cNvPr id="73" name="Straight Connector 72"/>
              <p:cNvCxnSpPr/>
              <p:nvPr/>
            </p:nvCxnSpPr>
            <p:spPr>
              <a:xfrm>
                <a:off x="914400" y="762000"/>
                <a:ext cx="17526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>
                <a:off x="914400" y="763685"/>
                <a:ext cx="0" cy="5725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Connector 74"/>
              <p:cNvCxnSpPr/>
              <p:nvPr/>
            </p:nvCxnSpPr>
            <p:spPr>
              <a:xfrm>
                <a:off x="2667000" y="760823"/>
                <a:ext cx="0" cy="629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2" name="TextBox 3"/>
            <p:cNvSpPr txBox="1"/>
            <p:nvPr/>
          </p:nvSpPr>
          <p:spPr>
            <a:xfrm>
              <a:off x="1399962" y="3873928"/>
              <a:ext cx="430687" cy="153657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CA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****</a:t>
              </a:r>
            </a:p>
          </p:txBody>
        </p:sp>
        <p:grpSp>
          <p:nvGrpSpPr>
            <p:cNvPr id="182" name="Group 181"/>
            <p:cNvGrpSpPr/>
            <p:nvPr/>
          </p:nvGrpSpPr>
          <p:grpSpPr>
            <a:xfrm>
              <a:off x="1010894" y="4057378"/>
              <a:ext cx="623628" cy="57592"/>
              <a:chOff x="914400" y="760823"/>
              <a:chExt cx="1752600" cy="62975"/>
            </a:xfrm>
          </p:grpSpPr>
          <p:cxnSp>
            <p:nvCxnSpPr>
              <p:cNvPr id="184" name="Straight Connector 183"/>
              <p:cNvCxnSpPr/>
              <p:nvPr/>
            </p:nvCxnSpPr>
            <p:spPr>
              <a:xfrm>
                <a:off x="914400" y="762000"/>
                <a:ext cx="17526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/>
              <p:cNvCxnSpPr/>
              <p:nvPr/>
            </p:nvCxnSpPr>
            <p:spPr>
              <a:xfrm>
                <a:off x="914400" y="763685"/>
                <a:ext cx="0" cy="5725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185"/>
              <p:cNvCxnSpPr/>
              <p:nvPr/>
            </p:nvCxnSpPr>
            <p:spPr>
              <a:xfrm>
                <a:off x="2667000" y="760823"/>
                <a:ext cx="0" cy="629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9" name="Group 158"/>
            <p:cNvGrpSpPr/>
            <p:nvPr/>
          </p:nvGrpSpPr>
          <p:grpSpPr>
            <a:xfrm>
              <a:off x="1016313" y="4036809"/>
              <a:ext cx="993434" cy="331258"/>
              <a:chOff x="914400" y="342880"/>
              <a:chExt cx="1904421" cy="450492"/>
            </a:xfrm>
          </p:grpSpPr>
          <p:grpSp>
            <p:nvGrpSpPr>
              <p:cNvPr id="161" name="Group 160"/>
              <p:cNvGrpSpPr/>
              <p:nvPr/>
            </p:nvGrpSpPr>
            <p:grpSpPr>
              <a:xfrm>
                <a:off x="914400" y="533401"/>
                <a:ext cx="1752601" cy="76200"/>
                <a:chOff x="914400" y="762000"/>
                <a:chExt cx="1752600" cy="76200"/>
              </a:xfrm>
            </p:grpSpPr>
            <p:cxnSp>
              <p:nvCxnSpPr>
                <p:cNvPr id="181" name="Straight Connector 180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3" name="Straight Connector 182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7" name="Straight Connector 186"/>
                <p:cNvCxnSpPr/>
                <p:nvPr/>
              </p:nvCxnSpPr>
              <p:spPr>
                <a:xfrm>
                  <a:off x="2664575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9" name="TextBox 3"/>
              <p:cNvSpPr txBox="1"/>
              <p:nvPr/>
            </p:nvSpPr>
            <p:spPr>
              <a:xfrm>
                <a:off x="1584647" y="342880"/>
                <a:ext cx="1234174" cy="450492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1103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81</TotalTime>
  <Words>180</Words>
  <Application>Microsoft Office PowerPoint</Application>
  <PresentationFormat>Custom</PresentationFormat>
  <Paragraphs>8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Presentation</vt:lpstr>
    </vt:vector>
  </TitlesOfParts>
  <Company>MRT www.Win2Farsi.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020</cp:revision>
  <cp:lastPrinted>2019-02-02T05:56:56Z</cp:lastPrinted>
  <dcterms:created xsi:type="dcterms:W3CDTF">2018-08-01T14:08:28Z</dcterms:created>
  <dcterms:modified xsi:type="dcterms:W3CDTF">2019-02-14T04:29:52Z</dcterms:modified>
</cp:coreProperties>
</file>